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125" autoAdjust="0"/>
  </p:normalViewPr>
  <p:slideViewPr>
    <p:cSldViewPr>
      <p:cViewPr>
        <p:scale>
          <a:sx n="100" d="100"/>
          <a:sy n="100" d="100"/>
        </p:scale>
        <p:origin x="-72" y="4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Indigo\crdshared\Pul_CC\Mendez%20Lab\Chang_Xu\Cell%20lines\Cell%20viability\20091026%20summary%20wout%20standar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Indigo\crdshared\Pul_CC\Mendez%20Lab\Chang_Xu\Cell%20lines\Cell%20viability\20091026%20summary%20wout%20standar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809930008748914E-2"/>
          <c:y val="5.092592592592593E-2"/>
          <c:w val="0.87361373578302703"/>
          <c:h val="0.85438320209973762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All0!$AG$2</c:f>
              <c:strCache>
                <c:ptCount val="1"/>
                <c:pt idx="0">
                  <c:v>UMSCC-17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H$3:$AH$6</c:f>
                <c:numCache>
                  <c:formatCode>General</c:formatCode>
                  <c:ptCount val="4"/>
                  <c:pt idx="0">
                    <c:v>2.4991129407635811E-2</c:v>
                  </c:pt>
                  <c:pt idx="1">
                    <c:v>2.5684995356288178E-2</c:v>
                  </c:pt>
                  <c:pt idx="2">
                    <c:v>5.3836743821816836E-2</c:v>
                  </c:pt>
                  <c:pt idx="3">
                    <c:v>0.1331282031507674</c:v>
                  </c:pt>
                </c:numCache>
              </c:numRef>
            </c:plus>
            <c:minus>
              <c:numRef>
                <c:f>All0!$AH$3:$AH$6</c:f>
                <c:numCache>
                  <c:formatCode>General</c:formatCode>
                  <c:ptCount val="4"/>
                  <c:pt idx="0">
                    <c:v>2.4991129407635811E-2</c:v>
                  </c:pt>
                  <c:pt idx="1">
                    <c:v>2.5684995356288178E-2</c:v>
                  </c:pt>
                  <c:pt idx="2">
                    <c:v>5.3836743821816836E-2</c:v>
                  </c:pt>
                  <c:pt idx="3">
                    <c:v>0.1331282031507674</c:v>
                  </c:pt>
                </c:numCache>
              </c:numRef>
            </c:minus>
          </c:errBars>
          <c:val>
            <c:numRef>
              <c:f>All0!$AG$3:$AG$6</c:f>
              <c:numCache>
                <c:formatCode>0.00</c:formatCode>
                <c:ptCount val="4"/>
                <c:pt idx="0">
                  <c:v>1</c:v>
                </c:pt>
                <c:pt idx="1">
                  <c:v>0.87855563257865099</c:v>
                </c:pt>
                <c:pt idx="2">
                  <c:v>0.86108655918217958</c:v>
                </c:pt>
                <c:pt idx="3">
                  <c:v>0.80578999214992131</c:v>
                </c:pt>
              </c:numCache>
            </c:numRef>
          </c:val>
        </c:ser>
        <c:ser>
          <c:idx val="3"/>
          <c:order val="1"/>
          <c:tx>
            <c:strRef>
              <c:f>All0!$Y$10</c:f>
              <c:strCache>
                <c:ptCount val="1"/>
                <c:pt idx="0">
                  <c:v>UMSCC-14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Z$11:$Z$14</c:f>
                <c:numCache>
                  <c:formatCode>General</c:formatCode>
                  <c:ptCount val="4"/>
                  <c:pt idx="0">
                    <c:v>0.18481095350429533</c:v>
                  </c:pt>
                  <c:pt idx="1">
                    <c:v>0.11548376225625472</c:v>
                  </c:pt>
                  <c:pt idx="2">
                    <c:v>0.23392127678361127</c:v>
                  </c:pt>
                  <c:pt idx="3">
                    <c:v>7.2737270467776102E-2</c:v>
                  </c:pt>
                </c:numCache>
              </c:numRef>
            </c:plus>
            <c:minus>
              <c:numRef>
                <c:f>All0!$Z$11:$Z$14</c:f>
                <c:numCache>
                  <c:formatCode>General</c:formatCode>
                  <c:ptCount val="4"/>
                  <c:pt idx="0">
                    <c:v>0.18481095350429533</c:v>
                  </c:pt>
                  <c:pt idx="1">
                    <c:v>0.11548376225625472</c:v>
                  </c:pt>
                  <c:pt idx="2">
                    <c:v>0.23392127678361127</c:v>
                  </c:pt>
                  <c:pt idx="3">
                    <c:v>7.2737270467776102E-2</c:v>
                  </c:pt>
                </c:numCache>
              </c:numRef>
            </c:minus>
          </c:errBars>
          <c:val>
            <c:numRef>
              <c:f>All0!$Y$11:$Y$14</c:f>
              <c:numCache>
                <c:formatCode>0.00</c:formatCode>
                <c:ptCount val="4"/>
                <c:pt idx="0">
                  <c:v>1</c:v>
                </c:pt>
                <c:pt idx="1">
                  <c:v>0.76039223926280419</c:v>
                </c:pt>
                <c:pt idx="2">
                  <c:v>0.81019408584812691</c:v>
                </c:pt>
                <c:pt idx="3">
                  <c:v>0.54043464532954588</c:v>
                </c:pt>
              </c:numCache>
            </c:numRef>
          </c:val>
        </c:ser>
        <c:ser>
          <c:idx val="4"/>
          <c:order val="2"/>
          <c:tx>
            <c:strRef>
              <c:f>All0!$AC$10</c:f>
              <c:strCache>
                <c:ptCount val="1"/>
                <c:pt idx="0">
                  <c:v>UMSCC-14C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D$11:$AD$14</c:f>
                <c:numCache>
                  <c:formatCode>General</c:formatCode>
                  <c:ptCount val="4"/>
                  <c:pt idx="0">
                    <c:v>0.41549770819925508</c:v>
                  </c:pt>
                  <c:pt idx="1">
                    <c:v>8.0260262010975511E-2</c:v>
                  </c:pt>
                  <c:pt idx="2">
                    <c:v>0.12842939664039976</c:v>
                  </c:pt>
                  <c:pt idx="3">
                    <c:v>1.0842773980860086E-2</c:v>
                  </c:pt>
                </c:numCache>
              </c:numRef>
            </c:plus>
            <c:minus>
              <c:numRef>
                <c:f>All0!$AD$11:$AD$14</c:f>
                <c:numCache>
                  <c:formatCode>General</c:formatCode>
                  <c:ptCount val="4"/>
                  <c:pt idx="0">
                    <c:v>0.41549770819925508</c:v>
                  </c:pt>
                  <c:pt idx="1">
                    <c:v>8.0260262010975511E-2</c:v>
                  </c:pt>
                  <c:pt idx="2">
                    <c:v>0.12842939664039976</c:v>
                  </c:pt>
                  <c:pt idx="3">
                    <c:v>1.0842773980860086E-2</c:v>
                  </c:pt>
                </c:numCache>
              </c:numRef>
            </c:minus>
          </c:errBars>
          <c:val>
            <c:numRef>
              <c:f>All0!$AC$11:$AC$14</c:f>
              <c:numCache>
                <c:formatCode>0.00</c:formatCode>
                <c:ptCount val="4"/>
                <c:pt idx="0">
                  <c:v>1</c:v>
                </c:pt>
                <c:pt idx="1">
                  <c:v>0.68900835957301065</c:v>
                </c:pt>
                <c:pt idx="2">
                  <c:v>0.63399953426682476</c:v>
                </c:pt>
                <c:pt idx="3">
                  <c:v>0.39106821641068218</c:v>
                </c:pt>
              </c:numCache>
            </c:numRef>
          </c:val>
        </c:ser>
        <c:ser>
          <c:idx val="2"/>
          <c:order val="3"/>
          <c:tx>
            <c:strRef>
              <c:f>All0!$AI$2</c:f>
              <c:strCache>
                <c:ptCount val="1"/>
                <c:pt idx="0">
                  <c:v>UMSCC-47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J$3:$AJ$6</c:f>
                <c:numCache>
                  <c:formatCode>General</c:formatCode>
                  <c:ptCount val="4"/>
                  <c:pt idx="0">
                    <c:v>7.3277456979570693E-2</c:v>
                  </c:pt>
                  <c:pt idx="1">
                    <c:v>9.4210443178546224E-2</c:v>
                  </c:pt>
                  <c:pt idx="2">
                    <c:v>0.12600331922317395</c:v>
                  </c:pt>
                  <c:pt idx="3">
                    <c:v>0.2724136325391362</c:v>
                  </c:pt>
                </c:numCache>
              </c:numRef>
            </c:plus>
            <c:minus>
              <c:numRef>
                <c:f>All0!$AJ$3:$AJ$6</c:f>
                <c:numCache>
                  <c:formatCode>General</c:formatCode>
                  <c:ptCount val="4"/>
                  <c:pt idx="0">
                    <c:v>7.3277456979570693E-2</c:v>
                  </c:pt>
                  <c:pt idx="1">
                    <c:v>9.4210443178546224E-2</c:v>
                  </c:pt>
                  <c:pt idx="2">
                    <c:v>0.12600331922317395</c:v>
                  </c:pt>
                  <c:pt idx="3">
                    <c:v>0.2724136325391362</c:v>
                  </c:pt>
                </c:numCache>
              </c:numRef>
            </c:minus>
          </c:errBars>
          <c:val>
            <c:numRef>
              <c:f>All0!$AI$3:$AI$6</c:f>
              <c:numCache>
                <c:formatCode>0.00</c:formatCode>
                <c:ptCount val="4"/>
                <c:pt idx="0">
                  <c:v>1</c:v>
                </c:pt>
                <c:pt idx="1">
                  <c:v>0.87258803070918178</c:v>
                </c:pt>
                <c:pt idx="2">
                  <c:v>0.83059641422463881</c:v>
                </c:pt>
                <c:pt idx="3">
                  <c:v>0.78001561784129558</c:v>
                </c:pt>
              </c:numCache>
            </c:numRef>
          </c:val>
        </c:ser>
        <c:ser>
          <c:idx val="0"/>
          <c:order val="4"/>
          <c:tx>
            <c:strRef>
              <c:f>All0!$AC$2</c:f>
              <c:strCache>
                <c:ptCount val="1"/>
                <c:pt idx="0">
                  <c:v>JHU-019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D$3:$AD$6</c:f>
                <c:numCache>
                  <c:formatCode>General</c:formatCode>
                  <c:ptCount val="4"/>
                  <c:pt idx="0">
                    <c:v>7.5130453655013585E-2</c:v>
                  </c:pt>
                  <c:pt idx="1">
                    <c:v>0.10521700808171262</c:v>
                  </c:pt>
                  <c:pt idx="2">
                    <c:v>1.0507747895917827E-2</c:v>
                  </c:pt>
                  <c:pt idx="3">
                    <c:v>8.4123786138941888E-3</c:v>
                  </c:pt>
                </c:numCache>
              </c:numRef>
            </c:plus>
            <c:minus>
              <c:numRef>
                <c:f>All0!$AD$3:$AD$6</c:f>
                <c:numCache>
                  <c:formatCode>General</c:formatCode>
                  <c:ptCount val="4"/>
                  <c:pt idx="0">
                    <c:v>7.5130453655013585E-2</c:v>
                  </c:pt>
                  <c:pt idx="1">
                    <c:v>0.10521700808171262</c:v>
                  </c:pt>
                  <c:pt idx="2">
                    <c:v>1.0507747895917827E-2</c:v>
                  </c:pt>
                  <c:pt idx="3">
                    <c:v>8.4123786138941888E-3</c:v>
                  </c:pt>
                </c:numCache>
              </c:numRef>
            </c:minus>
          </c:errBars>
          <c:cat>
            <c:numRef>
              <c:f>All0!$X$3:$X$6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All0!$AC$3:$AC$6</c:f>
              <c:numCache>
                <c:formatCode>0.00</c:formatCode>
                <c:ptCount val="4"/>
                <c:pt idx="0">
                  <c:v>1</c:v>
                </c:pt>
                <c:pt idx="1">
                  <c:v>1.8142867061876899</c:v>
                </c:pt>
                <c:pt idx="2">
                  <c:v>2.689071224034401</c:v>
                </c:pt>
                <c:pt idx="3">
                  <c:v>3.3653936858940594</c:v>
                </c:pt>
              </c:numCache>
            </c:numRef>
          </c:val>
        </c:ser>
        <c:ser>
          <c:idx val="5"/>
          <c:order val="5"/>
          <c:tx>
            <c:strRef>
              <c:f>All0!$AG$10</c:f>
              <c:strCache>
                <c:ptCount val="1"/>
                <c:pt idx="0">
                  <c:v>UMSCC-15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H$11:$AH$14</c:f>
                <c:numCache>
                  <c:formatCode>General</c:formatCode>
                  <c:ptCount val="4"/>
                  <c:pt idx="0">
                    <c:v>8.2806303892732108E-2</c:v>
                  </c:pt>
                  <c:pt idx="1">
                    <c:v>3.8712424509887385E-2</c:v>
                  </c:pt>
                  <c:pt idx="2">
                    <c:v>7.7878966755574999E-2</c:v>
                  </c:pt>
                  <c:pt idx="3">
                    <c:v>4.4963097284155679E-2</c:v>
                  </c:pt>
                </c:numCache>
              </c:numRef>
            </c:plus>
            <c:minus>
              <c:numRef>
                <c:f>All0!$AH$11:$AH$14</c:f>
                <c:numCache>
                  <c:formatCode>General</c:formatCode>
                  <c:ptCount val="4"/>
                  <c:pt idx="0">
                    <c:v>8.2806303892732108E-2</c:v>
                  </c:pt>
                  <c:pt idx="1">
                    <c:v>3.8712424509887385E-2</c:v>
                  </c:pt>
                  <c:pt idx="2">
                    <c:v>7.7878966755574999E-2</c:v>
                  </c:pt>
                  <c:pt idx="3">
                    <c:v>4.4963097284155679E-2</c:v>
                  </c:pt>
                </c:numCache>
              </c:numRef>
            </c:minus>
          </c:errBars>
          <c:val>
            <c:numRef>
              <c:f>All0!$AG$11:$AG$14</c:f>
              <c:numCache>
                <c:formatCode>0.00</c:formatCode>
                <c:ptCount val="4"/>
                <c:pt idx="0">
                  <c:v>1</c:v>
                </c:pt>
                <c:pt idx="1">
                  <c:v>1.2020393939564065</c:v>
                </c:pt>
                <c:pt idx="2">
                  <c:v>1.1444241888099602</c:v>
                </c:pt>
                <c:pt idx="3">
                  <c:v>1.4306202635299925</c:v>
                </c:pt>
              </c:numCache>
            </c:numRef>
          </c:val>
        </c:ser>
        <c:ser>
          <c:idx val="6"/>
          <c:order val="6"/>
          <c:tx>
            <c:strRef>
              <c:f>All0!$AI$10</c:f>
              <c:strCache>
                <c:ptCount val="1"/>
                <c:pt idx="0">
                  <c:v>UMSCC-15B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J$11:$AJ$14</c:f>
                <c:numCache>
                  <c:formatCode>General</c:formatCode>
                  <c:ptCount val="4"/>
                  <c:pt idx="0">
                    <c:v>1.710688343492232E-2</c:v>
                  </c:pt>
                  <c:pt idx="1">
                    <c:v>3.9963785515849809E-2</c:v>
                  </c:pt>
                  <c:pt idx="2">
                    <c:v>7.2331647747864353E-2</c:v>
                  </c:pt>
                  <c:pt idx="3">
                    <c:v>3.6681815570771013E-2</c:v>
                  </c:pt>
                </c:numCache>
              </c:numRef>
            </c:plus>
            <c:minus>
              <c:numRef>
                <c:f>All0!$AJ$11:$AJ$14</c:f>
                <c:numCache>
                  <c:formatCode>General</c:formatCode>
                  <c:ptCount val="4"/>
                  <c:pt idx="0">
                    <c:v>1.710688343492232E-2</c:v>
                  </c:pt>
                  <c:pt idx="1">
                    <c:v>3.9963785515849809E-2</c:v>
                  </c:pt>
                  <c:pt idx="2">
                    <c:v>7.2331647747864353E-2</c:v>
                  </c:pt>
                  <c:pt idx="3">
                    <c:v>3.6681815570771013E-2</c:v>
                  </c:pt>
                </c:numCache>
              </c:numRef>
            </c:minus>
          </c:errBars>
          <c:val>
            <c:numRef>
              <c:f>All0!$AI$11:$AI$14</c:f>
              <c:numCache>
                <c:formatCode>0.00</c:formatCode>
                <c:ptCount val="4"/>
                <c:pt idx="0">
                  <c:v>1</c:v>
                </c:pt>
                <c:pt idx="1">
                  <c:v>1.4276415636870232</c:v>
                </c:pt>
                <c:pt idx="2">
                  <c:v>1.6679059632346089</c:v>
                </c:pt>
                <c:pt idx="3">
                  <c:v>1.81108643371147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206272"/>
        <c:axId val="33207808"/>
      </c:barChart>
      <c:catAx>
        <c:axId val="33206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3207808"/>
        <c:crosses val="autoZero"/>
        <c:auto val="1"/>
        <c:lblAlgn val="ctr"/>
        <c:lblOffset val="100"/>
        <c:noMultiLvlLbl val="0"/>
      </c:catAx>
      <c:valAx>
        <c:axId val="33207808"/>
        <c:scaling>
          <c:orientation val="minMax"/>
        </c:scaling>
        <c:delete val="0"/>
        <c:axPos val="l"/>
        <c:numFmt formatCode="0%" sourceLinked="0"/>
        <c:majorTickMark val="out"/>
        <c:minorTickMark val="out"/>
        <c:tickLblPos val="nextTo"/>
        <c:txPr>
          <a:bodyPr/>
          <a:lstStyle/>
          <a:p>
            <a:pPr>
              <a:defRPr sz="8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3206272"/>
        <c:crosses val="autoZero"/>
        <c:crossBetween val="between"/>
        <c:majorUnit val="1"/>
        <c:minorUnit val="0.5"/>
      </c:valAx>
    </c:plotArea>
    <c:legend>
      <c:legendPos val="r"/>
      <c:layout>
        <c:manualLayout>
          <c:xMode val="edge"/>
          <c:yMode val="edge"/>
          <c:x val="0.13864020122484688"/>
          <c:y val="3.8167885264341957E-2"/>
          <c:w val="0.22979516147438098"/>
          <c:h val="0.46084130108736415"/>
        </c:manualLayout>
      </c:layout>
      <c:overlay val="0"/>
      <c:txPr>
        <a:bodyPr/>
        <a:lstStyle/>
        <a:p>
          <a:pPr>
            <a:defRPr sz="8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8099300087489E-2"/>
          <c:y val="5.0925925925925923E-2"/>
          <c:w val="0.87361373578302703"/>
          <c:h val="0.85438320209973762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All0!$AG$2</c:f>
              <c:strCache>
                <c:ptCount val="1"/>
                <c:pt idx="0">
                  <c:v>UMSCC-17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H$19:$AH$22</c:f>
                <c:numCache>
                  <c:formatCode>General</c:formatCode>
                  <c:ptCount val="4"/>
                  <c:pt idx="0">
                    <c:v>6.6989488104712253E-2</c:v>
                  </c:pt>
                  <c:pt idx="1">
                    <c:v>3.0435721142548586E-2</c:v>
                  </c:pt>
                  <c:pt idx="2">
                    <c:v>5.6812914369195118E-2</c:v>
                  </c:pt>
                  <c:pt idx="3">
                    <c:v>6.3679251700211326E-2</c:v>
                  </c:pt>
                </c:numCache>
              </c:numRef>
            </c:plus>
            <c:minus>
              <c:numRef>
                <c:f>All0!$AH$19:$AH$22</c:f>
                <c:numCache>
                  <c:formatCode>General</c:formatCode>
                  <c:ptCount val="4"/>
                  <c:pt idx="0">
                    <c:v>6.6989488104712253E-2</c:v>
                  </c:pt>
                  <c:pt idx="1">
                    <c:v>3.0435721142548586E-2</c:v>
                  </c:pt>
                  <c:pt idx="2">
                    <c:v>5.6812914369195118E-2</c:v>
                  </c:pt>
                  <c:pt idx="3">
                    <c:v>6.3679251700211326E-2</c:v>
                  </c:pt>
                </c:numCache>
              </c:numRef>
            </c:minus>
          </c:errBars>
          <c:val>
            <c:numRef>
              <c:f>All0!$AG$19:$AG$22</c:f>
              <c:numCache>
                <c:formatCode>0.00</c:formatCode>
                <c:ptCount val="4"/>
                <c:pt idx="0">
                  <c:v>1</c:v>
                </c:pt>
                <c:pt idx="1">
                  <c:v>1.0553959165243376</c:v>
                </c:pt>
                <c:pt idx="2">
                  <c:v>1.2945262116480099</c:v>
                </c:pt>
                <c:pt idx="3">
                  <c:v>1.4467924791508162</c:v>
                </c:pt>
              </c:numCache>
            </c:numRef>
          </c:val>
        </c:ser>
        <c:ser>
          <c:idx val="3"/>
          <c:order val="1"/>
          <c:tx>
            <c:strRef>
              <c:f>All0!$Y$10</c:f>
              <c:strCache>
                <c:ptCount val="1"/>
                <c:pt idx="0">
                  <c:v>UMSCC-14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Z$27:$Z$30</c:f>
                <c:numCache>
                  <c:formatCode>General</c:formatCode>
                  <c:ptCount val="4"/>
                  <c:pt idx="0">
                    <c:v>1.9017902114592949E-2</c:v>
                  </c:pt>
                  <c:pt idx="1">
                    <c:v>6.3913803649287851E-2</c:v>
                  </c:pt>
                  <c:pt idx="2">
                    <c:v>2.2977411188450557E-2</c:v>
                  </c:pt>
                  <c:pt idx="3">
                    <c:v>8.0304985564278078E-2</c:v>
                  </c:pt>
                </c:numCache>
              </c:numRef>
            </c:plus>
            <c:minus>
              <c:numRef>
                <c:f>All0!$Z$27:$Z$30</c:f>
                <c:numCache>
                  <c:formatCode>General</c:formatCode>
                  <c:ptCount val="4"/>
                  <c:pt idx="0">
                    <c:v>1.9017902114592949E-2</c:v>
                  </c:pt>
                  <c:pt idx="1">
                    <c:v>6.3913803649287851E-2</c:v>
                  </c:pt>
                  <c:pt idx="2">
                    <c:v>2.2977411188450557E-2</c:v>
                  </c:pt>
                  <c:pt idx="3">
                    <c:v>8.0304985564278078E-2</c:v>
                  </c:pt>
                </c:numCache>
              </c:numRef>
            </c:minus>
          </c:errBars>
          <c:val>
            <c:numRef>
              <c:f>All0!$Y$27:$Y$30</c:f>
              <c:numCache>
                <c:formatCode>0.00</c:formatCode>
                <c:ptCount val="4"/>
                <c:pt idx="0">
                  <c:v>1</c:v>
                </c:pt>
                <c:pt idx="1">
                  <c:v>1.2939731158728207</c:v>
                </c:pt>
                <c:pt idx="2">
                  <c:v>1.8307186277616221</c:v>
                </c:pt>
                <c:pt idx="3">
                  <c:v>2.1214115689022757</c:v>
                </c:pt>
              </c:numCache>
            </c:numRef>
          </c:val>
        </c:ser>
        <c:ser>
          <c:idx val="4"/>
          <c:order val="2"/>
          <c:tx>
            <c:strRef>
              <c:f>All0!$AC$10</c:f>
              <c:strCache>
                <c:ptCount val="1"/>
                <c:pt idx="0">
                  <c:v>UMSCC-14C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D$27:$AD$30</c:f>
                <c:numCache>
                  <c:formatCode>General</c:formatCode>
                  <c:ptCount val="4"/>
                  <c:pt idx="0">
                    <c:v>6.3225519299997562E-2</c:v>
                  </c:pt>
                  <c:pt idx="1">
                    <c:v>0.11228036680358854</c:v>
                  </c:pt>
                  <c:pt idx="2">
                    <c:v>3.4987132900885995E-2</c:v>
                  </c:pt>
                  <c:pt idx="3">
                    <c:v>2.8409921551607188E-2</c:v>
                  </c:pt>
                </c:numCache>
              </c:numRef>
            </c:plus>
            <c:minus>
              <c:numRef>
                <c:f>All0!$AD$27:$AD$30</c:f>
                <c:numCache>
                  <c:formatCode>General</c:formatCode>
                  <c:ptCount val="4"/>
                  <c:pt idx="0">
                    <c:v>6.3225519299997562E-2</c:v>
                  </c:pt>
                  <c:pt idx="1">
                    <c:v>0.11228036680358854</c:v>
                  </c:pt>
                  <c:pt idx="2">
                    <c:v>3.4987132900885995E-2</c:v>
                  </c:pt>
                  <c:pt idx="3">
                    <c:v>2.8409921551607188E-2</c:v>
                  </c:pt>
                </c:numCache>
              </c:numRef>
            </c:minus>
          </c:errBars>
          <c:val>
            <c:numRef>
              <c:f>All0!$AC$27:$AC$30</c:f>
              <c:numCache>
                <c:formatCode>0.00</c:formatCode>
                <c:ptCount val="4"/>
                <c:pt idx="0">
                  <c:v>1</c:v>
                </c:pt>
                <c:pt idx="1">
                  <c:v>1.5775994441197019</c:v>
                </c:pt>
                <c:pt idx="2">
                  <c:v>1.9704790029657941</c:v>
                </c:pt>
                <c:pt idx="3">
                  <c:v>2.4504659174624268</c:v>
                </c:pt>
              </c:numCache>
            </c:numRef>
          </c:val>
        </c:ser>
        <c:ser>
          <c:idx val="2"/>
          <c:order val="3"/>
          <c:tx>
            <c:strRef>
              <c:f>All0!$AI$2</c:f>
              <c:strCache>
                <c:ptCount val="1"/>
                <c:pt idx="0">
                  <c:v>UMSCC-47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J$19:$AJ$22</c:f>
                <c:numCache>
                  <c:formatCode>General</c:formatCode>
                  <c:ptCount val="4"/>
                  <c:pt idx="0">
                    <c:v>2.5110370596940556E-2</c:v>
                  </c:pt>
                  <c:pt idx="1">
                    <c:v>2.0405493372107248E-2</c:v>
                  </c:pt>
                  <c:pt idx="2">
                    <c:v>3.5387859370403542E-2</c:v>
                  </c:pt>
                  <c:pt idx="3">
                    <c:v>4.569842929782076E-2</c:v>
                  </c:pt>
                </c:numCache>
              </c:numRef>
            </c:plus>
            <c:minus>
              <c:numRef>
                <c:f>All0!$AJ$19:$AJ$22</c:f>
                <c:numCache>
                  <c:formatCode>General</c:formatCode>
                  <c:ptCount val="4"/>
                  <c:pt idx="0">
                    <c:v>2.5110370596940556E-2</c:v>
                  </c:pt>
                  <c:pt idx="1">
                    <c:v>2.0405493372107248E-2</c:v>
                  </c:pt>
                  <c:pt idx="2">
                    <c:v>3.5387859370403542E-2</c:v>
                  </c:pt>
                  <c:pt idx="3">
                    <c:v>4.569842929782076E-2</c:v>
                  </c:pt>
                </c:numCache>
              </c:numRef>
            </c:minus>
          </c:errBars>
          <c:val>
            <c:numRef>
              <c:f>All0!$AI$19:$AI$22</c:f>
              <c:numCache>
                <c:formatCode>0.00</c:formatCode>
                <c:ptCount val="4"/>
                <c:pt idx="0">
                  <c:v>1</c:v>
                </c:pt>
                <c:pt idx="1">
                  <c:v>1.4469828767617321</c:v>
                </c:pt>
                <c:pt idx="2">
                  <c:v>2.2688672985098313</c:v>
                </c:pt>
                <c:pt idx="3">
                  <c:v>3.3197285093983058</c:v>
                </c:pt>
              </c:numCache>
            </c:numRef>
          </c:val>
        </c:ser>
        <c:ser>
          <c:idx val="0"/>
          <c:order val="4"/>
          <c:tx>
            <c:strRef>
              <c:f>All0!$AC$2</c:f>
              <c:strCache>
                <c:ptCount val="1"/>
                <c:pt idx="0">
                  <c:v>JHU-019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D$19:$AD$22</c:f>
                <c:numCache>
                  <c:formatCode>General</c:formatCode>
                  <c:ptCount val="4"/>
                  <c:pt idx="0">
                    <c:v>3.3358380566286795E-2</c:v>
                  </c:pt>
                  <c:pt idx="1">
                    <c:v>3.5486248604782743E-2</c:v>
                  </c:pt>
                  <c:pt idx="2">
                    <c:v>4.0302338145134696E-2</c:v>
                  </c:pt>
                  <c:pt idx="3">
                    <c:v>3.5762200445737247E-2</c:v>
                  </c:pt>
                </c:numCache>
              </c:numRef>
            </c:plus>
            <c:minus>
              <c:numRef>
                <c:f>All0!$AD$19:$AD$22</c:f>
                <c:numCache>
                  <c:formatCode>General</c:formatCode>
                  <c:ptCount val="4"/>
                  <c:pt idx="0">
                    <c:v>3.3358380566286795E-2</c:v>
                  </c:pt>
                  <c:pt idx="1">
                    <c:v>3.5486248604782743E-2</c:v>
                  </c:pt>
                  <c:pt idx="2">
                    <c:v>4.0302338145134696E-2</c:v>
                  </c:pt>
                  <c:pt idx="3">
                    <c:v>3.5762200445737247E-2</c:v>
                  </c:pt>
                </c:numCache>
              </c:numRef>
            </c:minus>
          </c:errBars>
          <c:cat>
            <c:numRef>
              <c:f>All0!$X$3:$X$6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All0!$AC$19:$AC$22</c:f>
              <c:numCache>
                <c:formatCode>0.00</c:formatCode>
                <c:ptCount val="4"/>
                <c:pt idx="0">
                  <c:v>1</c:v>
                </c:pt>
                <c:pt idx="1">
                  <c:v>1.6703079311691009</c:v>
                </c:pt>
                <c:pt idx="2">
                  <c:v>2.9807488466107368</c:v>
                </c:pt>
                <c:pt idx="3">
                  <c:v>3.4815317224643834</c:v>
                </c:pt>
              </c:numCache>
            </c:numRef>
          </c:val>
        </c:ser>
        <c:ser>
          <c:idx val="5"/>
          <c:order val="5"/>
          <c:tx>
            <c:strRef>
              <c:f>All0!$AG$26</c:f>
              <c:strCache>
                <c:ptCount val="1"/>
                <c:pt idx="0">
                  <c:v>UMSCC-15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H$27:$AH$30</c:f>
                <c:numCache>
                  <c:formatCode>General</c:formatCode>
                  <c:ptCount val="4"/>
                  <c:pt idx="0">
                    <c:v>4.4372933869740651E-2</c:v>
                  </c:pt>
                  <c:pt idx="1">
                    <c:v>1.8330872563590575E-2</c:v>
                  </c:pt>
                  <c:pt idx="2">
                    <c:v>6.1487197390692493E-2</c:v>
                  </c:pt>
                  <c:pt idx="3">
                    <c:v>0.1730183415419915</c:v>
                  </c:pt>
                </c:numCache>
              </c:numRef>
            </c:plus>
            <c:minus>
              <c:numRef>
                <c:f>All0!$AH$27:$AH$30</c:f>
                <c:numCache>
                  <c:formatCode>General</c:formatCode>
                  <c:ptCount val="4"/>
                  <c:pt idx="0">
                    <c:v>4.4372933869740651E-2</c:v>
                  </c:pt>
                  <c:pt idx="1">
                    <c:v>1.8330872563590575E-2</c:v>
                  </c:pt>
                  <c:pt idx="2">
                    <c:v>6.1487197390692493E-2</c:v>
                  </c:pt>
                  <c:pt idx="3">
                    <c:v>0.1730183415419915</c:v>
                  </c:pt>
                </c:numCache>
              </c:numRef>
            </c:minus>
          </c:errBars>
          <c:val>
            <c:numRef>
              <c:f>All0!$AG$27:$AG$30</c:f>
              <c:numCache>
                <c:formatCode>0.00</c:formatCode>
                <c:ptCount val="4"/>
                <c:pt idx="0">
                  <c:v>1</c:v>
                </c:pt>
                <c:pt idx="1">
                  <c:v>1.7903050695352114</c:v>
                </c:pt>
                <c:pt idx="2">
                  <c:v>1.9545418182671206</c:v>
                </c:pt>
                <c:pt idx="3">
                  <c:v>4.4705664047580242</c:v>
                </c:pt>
              </c:numCache>
            </c:numRef>
          </c:val>
        </c:ser>
        <c:ser>
          <c:idx val="6"/>
          <c:order val="6"/>
          <c:tx>
            <c:strRef>
              <c:f>All0!$AI$26</c:f>
              <c:strCache>
                <c:ptCount val="1"/>
                <c:pt idx="0">
                  <c:v>UMSCC-15B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ll0!$AJ$27:$AJ$30</c:f>
                <c:numCache>
                  <c:formatCode>General</c:formatCode>
                  <c:ptCount val="4"/>
                  <c:pt idx="0">
                    <c:v>3.7396714735593799E-2</c:v>
                  </c:pt>
                  <c:pt idx="1">
                    <c:v>3.3224044922551932E-2</c:v>
                  </c:pt>
                  <c:pt idx="2">
                    <c:v>2.0369109550271582E-2</c:v>
                  </c:pt>
                  <c:pt idx="3">
                    <c:v>5.6299051065721327E-2</c:v>
                  </c:pt>
                </c:numCache>
              </c:numRef>
            </c:plus>
            <c:minus>
              <c:numRef>
                <c:f>All0!$AJ$27:$AJ$30</c:f>
                <c:numCache>
                  <c:formatCode>General</c:formatCode>
                  <c:ptCount val="4"/>
                  <c:pt idx="0">
                    <c:v>3.7396714735593799E-2</c:v>
                  </c:pt>
                  <c:pt idx="1">
                    <c:v>3.3224044922551932E-2</c:v>
                  </c:pt>
                  <c:pt idx="2">
                    <c:v>2.0369109550271582E-2</c:v>
                  </c:pt>
                  <c:pt idx="3">
                    <c:v>5.6299051065721327E-2</c:v>
                  </c:pt>
                </c:numCache>
              </c:numRef>
            </c:minus>
          </c:errBars>
          <c:val>
            <c:numRef>
              <c:f>All0!$AI$27:$AI$30</c:f>
              <c:numCache>
                <c:formatCode>0.00</c:formatCode>
                <c:ptCount val="4"/>
                <c:pt idx="0">
                  <c:v>1</c:v>
                </c:pt>
                <c:pt idx="1">
                  <c:v>1.636910068468173</c:v>
                </c:pt>
                <c:pt idx="2">
                  <c:v>2.1632907920145463</c:v>
                </c:pt>
                <c:pt idx="3">
                  <c:v>3.08424732116591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276672"/>
        <c:axId val="33278208"/>
      </c:barChart>
      <c:catAx>
        <c:axId val="33276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3278208"/>
        <c:crosses val="autoZero"/>
        <c:auto val="1"/>
        <c:lblAlgn val="ctr"/>
        <c:lblOffset val="100"/>
        <c:noMultiLvlLbl val="0"/>
      </c:catAx>
      <c:valAx>
        <c:axId val="33278208"/>
        <c:scaling>
          <c:orientation val="minMax"/>
        </c:scaling>
        <c:delete val="0"/>
        <c:axPos val="l"/>
        <c:numFmt formatCode="0%" sourceLinked="0"/>
        <c:majorTickMark val="out"/>
        <c:minorTickMark val="out"/>
        <c:tickLblPos val="nextTo"/>
        <c:txPr>
          <a:bodyPr/>
          <a:lstStyle/>
          <a:p>
            <a:pPr>
              <a:defRPr sz="8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3276672"/>
        <c:crosses val="autoZero"/>
        <c:crossBetween val="between"/>
        <c:majorUnit val="1"/>
        <c:minorUnit val="0.5"/>
      </c:valAx>
    </c:plotArea>
    <c:legend>
      <c:legendPos val="r"/>
      <c:layout>
        <c:manualLayout>
          <c:xMode val="edge"/>
          <c:yMode val="edge"/>
          <c:x val="0.13864020122484688"/>
          <c:y val="3.8167885264341957E-2"/>
          <c:w val="0.22979516147438092"/>
          <c:h val="0.46084130108736415"/>
        </c:manualLayout>
      </c:layout>
      <c:overlay val="0"/>
      <c:txPr>
        <a:bodyPr/>
        <a:lstStyle/>
        <a:p>
          <a:pPr>
            <a:defRPr sz="8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A7AEE2-228F-4792-853F-9B5F6E88E088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8C453-0D31-4A81-BF3B-5550D6C3831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8825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200" b="0" i="0" u="none" strike="noStrike" kern="0" cap="none" spc="0" normalizeH="0" baseline="0" noProof="0" dirty="0" smtClean="0">
              <a:ln>
                <a:noFill/>
              </a:ln>
              <a:solidFill>
                <a:srgbClr val="FF9933"/>
              </a:solidFill>
              <a:effectLst/>
              <a:uLnTx/>
              <a:uFillTx/>
              <a:latin typeface="Arial"/>
              <a:ea typeface="+mj-ea"/>
              <a:cs typeface="+mj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38C453-0D31-4A81-BF3B-5550D6C3831C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018400-317F-4BF2-B857-FBB8CA043322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F8104-3DF7-4476-B805-ABC45CC11A3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85"/>
          <p:cNvSpPr txBox="1">
            <a:spLocks noChangeArrowheads="1"/>
          </p:cNvSpPr>
          <p:nvPr/>
        </p:nvSpPr>
        <p:spPr bwMode="auto">
          <a:xfrm>
            <a:off x="652462" y="1219200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14" name="TextBox 186"/>
          <p:cNvSpPr txBox="1">
            <a:spLocks noChangeArrowheads="1"/>
          </p:cNvSpPr>
          <p:nvPr/>
        </p:nvSpPr>
        <p:spPr bwMode="auto">
          <a:xfrm>
            <a:off x="4495800" y="1219200"/>
            <a:ext cx="28725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15" name="Text Box 17"/>
          <p:cNvSpPr txBox="1">
            <a:spLocks noChangeArrowheads="1"/>
          </p:cNvSpPr>
          <p:nvPr/>
        </p:nvSpPr>
        <p:spPr bwMode="auto">
          <a:xfrm>
            <a:off x="1905000" y="3487579"/>
            <a:ext cx="1752600" cy="246221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Days after seeding of the cells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 Box 17"/>
          <p:cNvSpPr txBox="1">
            <a:spLocks noChangeArrowheads="1"/>
          </p:cNvSpPr>
          <p:nvPr/>
        </p:nvSpPr>
        <p:spPr bwMode="auto">
          <a:xfrm>
            <a:off x="5867400" y="3487579"/>
            <a:ext cx="1752600" cy="246221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Days after seeding of the cells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 Box 17"/>
          <p:cNvSpPr txBox="1">
            <a:spLocks noChangeArrowheads="1"/>
          </p:cNvSpPr>
          <p:nvPr/>
        </p:nvSpPr>
        <p:spPr bwMode="auto">
          <a:xfrm>
            <a:off x="4614446" y="1600200"/>
            <a:ext cx="338554" cy="160020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Growth rate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 Box 17"/>
          <p:cNvSpPr txBox="1">
            <a:spLocks noChangeArrowheads="1"/>
          </p:cNvSpPr>
          <p:nvPr/>
        </p:nvSpPr>
        <p:spPr bwMode="auto">
          <a:xfrm>
            <a:off x="694908" y="1600200"/>
            <a:ext cx="338554" cy="160020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vert="vert270"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Growth rate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0" name="Chart 9"/>
          <p:cNvGraphicFramePr/>
          <p:nvPr/>
        </p:nvGraphicFramePr>
        <p:xfrm>
          <a:off x="4953000" y="1371600"/>
          <a:ext cx="3505200" cy="21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/>
          <p:nvPr/>
        </p:nvGraphicFramePr>
        <p:xfrm>
          <a:off x="990600" y="1371600"/>
          <a:ext cx="3505200" cy="21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Rectangle 11"/>
          <p:cNvSpPr/>
          <p:nvPr/>
        </p:nvSpPr>
        <p:spPr>
          <a:xfrm>
            <a:off x="685800" y="4495800"/>
            <a:ext cx="78486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itchFamily="18" charset="0"/>
                <a:cs typeface="Times New Roman" pitchFamily="18" charset="0"/>
              </a:rPr>
              <a:t>Figure S5. Anchorage dependent and independent growth rates of OSCC cell lines. 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Growth rates with and without anchorage dependence were determined using standard 96-well tissue culture plates (A) and the plates coated with Poly-HEMA (B). The growth rates were measured with 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CellTiter-Glo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Luminescent Cell Viability Assay kit (</a:t>
            </a:r>
            <a:r>
              <a:rPr lang="en-US" sz="1000" dirty="0" err="1">
                <a:latin typeface="Times New Roman" pitchFamily="18" charset="0"/>
                <a:cs typeface="Times New Roman" pitchFamily="18" charset="0"/>
              </a:rPr>
              <a:t>Promega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, Madison, WI). The growth rates are presented as the average percentage of growth relative to day 0 from 3 repeated wells and error bars represent the standard deviation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1</TotalTime>
  <Words>106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red Hutchinson Cancer Research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, Chang</dc:creator>
  <cp:lastModifiedBy>Xu, Chang</cp:lastModifiedBy>
  <cp:revision>54</cp:revision>
  <dcterms:created xsi:type="dcterms:W3CDTF">2011-10-10T19:16:02Z</dcterms:created>
  <dcterms:modified xsi:type="dcterms:W3CDTF">2012-12-01T00:49:51Z</dcterms:modified>
</cp:coreProperties>
</file>